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64">
  <p:sldMasterIdLst>
    <p:sldMasterId id="2147483648" r:id="rId1"/>
  </p:sldMasterIdLst>
  <p:notesMasterIdLst>
    <p:notesMasterId r:id="rId6"/>
  </p:notesMasterIdLst>
  <p:sldIdLst>
    <p:sldId id="317" r:id="rId2"/>
    <p:sldId id="311" r:id="rId3"/>
    <p:sldId id="260" r:id="rId4"/>
    <p:sldId id="315" r:id="rId5"/>
  </p:sldIdLst>
  <p:sldSz cx="6858000" cy="9906000" type="A4"/>
  <p:notesSz cx="6735763" cy="9799638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96" autoAdjust="0"/>
    <p:restoredTop sz="93514" autoAdjust="0"/>
  </p:normalViewPr>
  <p:slideViewPr>
    <p:cSldViewPr>
      <p:cViewPr>
        <p:scale>
          <a:sx n="100" d="100"/>
          <a:sy n="100" d="100"/>
        </p:scale>
        <p:origin x="-1644" y="102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8998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8998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D7AABE-AE46-414F-9FE0-48031B328C8F}" type="datetimeFigureOut">
              <a:rPr lang="zh-CN" altLang="en-US" smtClean="0"/>
              <a:pPr/>
              <a:t>2017/4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097088" y="735013"/>
            <a:ext cx="2541587" cy="36750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3577" y="4654828"/>
            <a:ext cx="5388610" cy="44098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307955"/>
            <a:ext cx="2918831" cy="48998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15373" y="9307955"/>
            <a:ext cx="2918831" cy="48998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B1D5EF-E7B3-4CE1-816B-1E6A205E241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26647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Brachyury</a:t>
            </a:r>
            <a:r>
              <a:rPr lang="zh-CN" altLang="en-US" dirty="0" smtClean="0"/>
              <a:t>改为</a:t>
            </a:r>
            <a:r>
              <a:rPr lang="en-US" altLang="zh-CN" dirty="0" smtClean="0"/>
              <a:t>T,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B1D5EF-E7B3-4CE1-816B-1E6A205E2413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47441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7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3730059"/>
              </p:ext>
            </p:extLst>
          </p:nvPr>
        </p:nvGraphicFramePr>
        <p:xfrm>
          <a:off x="620688" y="1372345"/>
          <a:ext cx="5328592" cy="7495559"/>
        </p:xfrm>
        <a:graphic>
          <a:graphicData uri="http://schemas.openxmlformats.org/drawingml/2006/table">
            <a:tbl>
              <a:tblPr/>
              <a:tblGrid>
                <a:gridCol w="864096"/>
                <a:gridCol w="186612"/>
                <a:gridCol w="2477684"/>
                <a:gridCol w="1124745"/>
                <a:gridCol w="675455"/>
              </a:tblGrid>
              <a:tr h="556319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s</a:t>
                      </a:r>
                    </a:p>
                  </a:txBody>
                  <a:tcPr marL="4085" marR="4085" marT="4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( 5’-3’ )</a:t>
                      </a:r>
                    </a:p>
                  </a:txBody>
                  <a:tcPr marL="4085" marR="4085" marT="4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nealing temperature </a:t>
                      </a:r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zh-CN" alt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5" marR="4085" marT="4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duct size (bp)</a:t>
                      </a:r>
                    </a:p>
                  </a:txBody>
                  <a:tcPr marL="4085" marR="4085" marT="4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fp</a:t>
                      </a:r>
                      <a:endParaRPr lang="en-US" sz="105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CAGCGAGGAGAAATGG 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6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TCACCAGGTTAATGAGAAGC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chyury (T)</a:t>
                      </a:r>
                      <a:endParaRPr lang="en-US" sz="105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CTAAGGAACCACCGGTCATC 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GACTGCAGCATGGACAG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nt2</a:t>
                      </a:r>
                      <a:endParaRPr lang="en-US" sz="105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AGGAGGCCAACGTAGAAG 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8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CCATCGGGGATCTTGGGT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omes</a:t>
                      </a:r>
                      <a:endParaRPr lang="en-US" sz="105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TATGGCTCAAATTCCAC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GAACCACTTCCACGAAA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k1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AGCTCAGCACACAGAAA 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8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GGGAATGGTGAGTGTTT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f5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GTCAATGGCTCCCACGAA  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ACTTGCATGGAGTTTTCC  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xa2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GACTGGAGCAGCTACTAC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6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CCCACATAGGATGACA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altLang="zh-CN" sz="105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dh</a:t>
                      </a:r>
                      <a:endParaRPr lang="en-US" sz="105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GCAAAGTGGAGATTGTTG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4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CCTGGAAGATGGTGATGG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l1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TCCGAGTGTGGTTTCAA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4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TCATGTCTCTCCGGACT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f2c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GTCAGTTGGGAGCTTGC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5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TCGAAGGGGTGGTGGTA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sp1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CTGCAGCGGGGTGTCGTG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9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CGGCGTCCAGGTTTCTA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h6</a:t>
                      </a:r>
                      <a:endParaRPr lang="en-US" sz="105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GCCCAGATGGCTGACTT 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5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CAGCATGGCCATGTCCT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l7</a:t>
                      </a:r>
                      <a:endParaRPr lang="en-US" sz="105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ACAACGTGGCTCTTCTA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7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CCGTCCCATTGAGCTTC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nog</a:t>
                      </a:r>
                      <a:endParaRPr lang="en-US" sz="105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TGCACTCAAGGACAGGT 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6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TGCTGAGCCCTTCTGAATC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stin</a:t>
                      </a:r>
                      <a:endParaRPr lang="en-US" sz="105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GAGAGTCGCTTAGAGGT 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GCCAGCTGGAACTTTTC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kx2.5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AGTGCTCTCCTGCTTTCC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6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TTTGTCCAGCTCCACT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t4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AGGGCCAGGCAGGAGCACGAG 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5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TAGGGAGGGCTTCGGGCACTT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x1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AACAGAGTTCGTCCATCT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3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TCCCAGCTCTTAGTCCATT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x17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AAAGACGAACGCAAGCGGT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TGCGCTTCACCTGCTTG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S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AGCCGACTTAGAACTGG 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GGGACAGTGGGAATCTCG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220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x5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GCCGATACAGATGAGGG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7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52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GTGGAACTTCAGCCACAG</a:t>
                      </a:r>
                    </a:p>
                  </a:txBody>
                  <a:tcPr marL="4085" marR="4085" marT="408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2" name="矩形 1"/>
          <p:cNvSpPr/>
          <p:nvPr/>
        </p:nvSpPr>
        <p:spPr>
          <a:xfrm>
            <a:off x="548680" y="1062336"/>
            <a:ext cx="489654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 smtClean="0" bmk="OLE_LINK27">
                <a:latin typeface="Times New Roman" panose="02020603050405020304" pitchFamily="18" charset="0"/>
                <a:ea typeface="宋体" pitchFamily="2" charset="-122"/>
                <a:cs typeface="Times New Roman" panose="02020603050405020304" pitchFamily="18" charset="0"/>
              </a:rPr>
              <a:t>Table S1. List </a:t>
            </a:r>
            <a:r>
              <a:rPr lang="en-US" altLang="zh-CN" sz="1200" dirty="0" bmk="OLE_LINK27">
                <a:latin typeface="Times New Roman" panose="02020603050405020304" pitchFamily="18" charset="0"/>
                <a:ea typeface="宋体" pitchFamily="2" charset="-122"/>
                <a:cs typeface="Times New Roman" panose="02020603050405020304" pitchFamily="18" charset="0"/>
              </a:rPr>
              <a:t>of primer sequences for </a:t>
            </a:r>
            <a:r>
              <a:rPr lang="en-US" altLang="zh-CN" sz="1200" dirty="0" smtClean="0" bmk="OLE_LINK27">
                <a:latin typeface="Times New Roman" panose="02020603050405020304" pitchFamily="18" charset="0"/>
                <a:ea typeface="宋体" pitchFamily="2" charset="-122"/>
                <a:cs typeface="Times New Roman" panose="02020603050405020304" pitchFamily="18" charset="0"/>
              </a:rPr>
              <a:t>PCR detection </a:t>
            </a:r>
            <a:endParaRPr lang="en-US" altLang="zh-CN" sz="2800" dirty="0">
              <a:latin typeface="Times New Roman" panose="02020603050405020304" pitchFamily="18" charset="0"/>
              <a:ea typeface="宋体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332656" y="344488"/>
            <a:ext cx="612068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dirty="0" smtClean="0" bmk="OLE_LINK27">
                <a:latin typeface="Times New Roman" panose="02020603050405020304" pitchFamily="18" charset="0"/>
                <a:ea typeface="宋体" pitchFamily="2" charset="-122"/>
                <a:cs typeface="Times New Roman" panose="02020603050405020304" pitchFamily="18" charset="0"/>
              </a:rPr>
              <a:t>Table S1                                                                                   Chen et al. </a:t>
            </a:r>
          </a:p>
        </p:txBody>
      </p:sp>
    </p:spTree>
    <p:extLst>
      <p:ext uri="{BB962C8B-B14F-4D97-AF65-F5344CB8AC3E}">
        <p14:creationId xmlns:p14="http://schemas.microsoft.com/office/powerpoint/2010/main" val="30188386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矩形 11"/>
          <p:cNvSpPr/>
          <p:nvPr/>
        </p:nvSpPr>
        <p:spPr>
          <a:xfrm>
            <a:off x="476672" y="6777007"/>
            <a:ext cx="590465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S1. Isolation and characterization of the samples for microRNA microarray assay. (A) Schematic diagram of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trategy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or sample collecti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(B) FACS sorting of T-GFP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-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GFP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subpopulations and the purity detection. (C)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FACS sorting of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LK1</a:t>
            </a:r>
            <a:r>
              <a:rPr lang="en-US" altLang="zh-CN" sz="1200" baseline="300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/CXCR4</a:t>
            </a:r>
            <a:r>
              <a:rPr lang="en-US" altLang="zh-CN" sz="1200" baseline="30000" dirty="0">
                <a:latin typeface="Times New Roman" pitchFamily="18" charset="0"/>
                <a:cs typeface="Times New Roman" pitchFamily="18" charset="0"/>
              </a:rPr>
              <a:t>- 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LK1</a:t>
            </a:r>
            <a:r>
              <a:rPr lang="en-US" altLang="zh-CN" sz="12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/CXCR4</a:t>
            </a:r>
            <a:r>
              <a:rPr lang="en-US" altLang="zh-CN" sz="12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subpopulations and the purity detection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D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T-PCR analysis of T expression in unsorted, T-GFP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-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d T-GFP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ells. (E) RT-PCR analysis of cardiac progenitor marker genes in unsorted, FLK1</a:t>
            </a:r>
            <a:r>
              <a:rPr lang="en-US" altLang="zh-CN" sz="1200" baseline="30000" dirty="0">
                <a:latin typeface="Times New Roman" pitchFamily="18" charset="0"/>
                <a:cs typeface="Times New Roman" pitchFamily="18" charset="0"/>
              </a:rPr>
              <a:t>-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/CXCR4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-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d FLK1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/CXCR4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subpopulations.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32656" y="344488"/>
            <a:ext cx="612068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dirty="0" smtClean="0" bmk="OLE_LINK27">
                <a:latin typeface="Times New Roman" panose="02020603050405020304" pitchFamily="18" charset="0"/>
                <a:ea typeface="宋体" pitchFamily="2" charset="-122"/>
                <a:cs typeface="Times New Roman" panose="02020603050405020304" pitchFamily="18" charset="0"/>
              </a:rPr>
              <a:t>Figure S1                                                                                  Chen et al. </a:t>
            </a:r>
          </a:p>
        </p:txBody>
      </p:sp>
      <p:pic>
        <p:nvPicPr>
          <p:cNvPr id="2" name="Picture 2" descr="D:\工作\PUBLICATION\STEM CELLS INTERNATIONAL\figure S1 sample collection and identification 170115 simplified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1588" y="1712640"/>
            <a:ext cx="4313237" cy="49037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/>
          <p:cNvSpPr/>
          <p:nvPr/>
        </p:nvSpPr>
        <p:spPr>
          <a:xfrm>
            <a:off x="404664" y="8063860"/>
            <a:ext cx="590465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 smtClean="0" bmk="OLE_LINK27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igure S2. </a:t>
            </a:r>
            <a:r>
              <a:rPr lang="en-US" altLang="zh-CN" sz="1200" kern="100" dirty="0" bmk="OLE_LINK27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K</a:t>
            </a:r>
            <a:r>
              <a:rPr lang="en-US" altLang="zh-CN" sz="1200" kern="100" dirty="0" smtClean="0" bmk="OLE_LINK27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nockdown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of miR-142-3p does not affect the self-renewal and cardiomyocyte differentiation of ESCs. 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ESCs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were transfected 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with </a:t>
            </a:r>
            <a:r>
              <a:rPr lang="en-US" altLang="zh-CN" sz="1200" dirty="0">
                <a:latin typeface="Times New Roman" panose="02020603050405020304" pitchFamily="18" charset="0"/>
                <a:ea typeface="楷体" pitchFamily="49" charset="-122"/>
                <a:cs typeface="Times New Roman" panose="02020603050405020304" pitchFamily="18" charset="0"/>
              </a:rPr>
              <a:t>100 </a:t>
            </a:r>
            <a:r>
              <a:rPr lang="en-US" altLang="zh-CN" sz="1200" dirty="0" err="1">
                <a:latin typeface="Times New Roman" panose="02020603050405020304" pitchFamily="18" charset="0"/>
                <a:ea typeface="楷体" pitchFamily="49" charset="-122"/>
                <a:cs typeface="Times New Roman" panose="02020603050405020304" pitchFamily="18" charset="0"/>
              </a:rPr>
              <a:t>nM</a:t>
            </a:r>
            <a:r>
              <a:rPr lang="en-US" altLang="zh-CN" sz="1200" dirty="0">
                <a:latin typeface="Times New Roman" panose="02020603050405020304" pitchFamily="18" charset="0"/>
                <a:ea typeface="楷体" pitchFamily="49" charset="-122"/>
                <a:cs typeface="Times New Roman" panose="02020603050405020304" pitchFamily="18" charset="0"/>
              </a:rPr>
              <a:t> miR-142-3p inhibitor or scramble </a:t>
            </a:r>
            <a:r>
              <a:rPr lang="en-US" altLang="zh-CN" sz="1200" dirty="0" smtClean="0">
                <a:latin typeface="Times New Roman" panose="02020603050405020304" pitchFamily="18" charset="0"/>
                <a:ea typeface="楷体" pitchFamily="49" charset="-122"/>
                <a:cs typeface="Times New Roman" panose="02020603050405020304" pitchFamily="18" charset="0"/>
              </a:rPr>
              <a:t>control for 48h.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(A) </a:t>
            </a:r>
            <a:r>
              <a:rPr lang="en-US" altLang="zh-CN" sz="1200" dirty="0" err="1" smtClean="0">
                <a:latin typeface="Times New Roman" panose="02020603050405020304" pitchFamily="18" charset="0"/>
                <a:ea typeface="楷体" pitchFamily="49" charset="-122"/>
                <a:cs typeface="Times New Roman" panose="02020603050405020304" pitchFamily="18" charset="0"/>
              </a:rPr>
              <a:t>qRT</a:t>
            </a:r>
            <a:r>
              <a:rPr lang="en-US" altLang="zh-CN" sz="1200" dirty="0" smtClean="0">
                <a:latin typeface="Times New Roman" panose="02020603050405020304" pitchFamily="18" charset="0"/>
                <a:ea typeface="楷体" pitchFamily="49" charset="-122"/>
                <a:cs typeface="Times New Roman" panose="02020603050405020304" pitchFamily="18" charset="0"/>
              </a:rPr>
              <a:t>-PCR analysis of miR-142-3p in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ESCs  transfection 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with </a:t>
            </a:r>
            <a:r>
              <a:rPr lang="en-US" altLang="zh-CN" sz="1200" dirty="0" smtClean="0">
                <a:latin typeface="Times New Roman" panose="02020603050405020304" pitchFamily="18" charset="0"/>
                <a:ea typeface="楷体" pitchFamily="49" charset="-122"/>
                <a:cs typeface="Times New Roman" panose="02020603050405020304" pitchFamily="18" charset="0"/>
              </a:rPr>
              <a:t>100 </a:t>
            </a:r>
            <a:r>
              <a:rPr lang="en-US" altLang="zh-CN" sz="1200" dirty="0" err="1" smtClean="0">
                <a:latin typeface="Times New Roman" panose="02020603050405020304" pitchFamily="18" charset="0"/>
                <a:ea typeface="楷体" pitchFamily="49" charset="-122"/>
                <a:cs typeface="Times New Roman" panose="02020603050405020304" pitchFamily="18" charset="0"/>
              </a:rPr>
              <a:t>nM</a:t>
            </a:r>
            <a:r>
              <a:rPr lang="en-US" altLang="zh-CN" sz="1200" dirty="0" smtClean="0">
                <a:latin typeface="Times New Roman" panose="02020603050405020304" pitchFamily="18" charset="0"/>
                <a:ea typeface="楷体" pitchFamily="49" charset="-122"/>
                <a:cs typeface="Times New Roman" panose="02020603050405020304" pitchFamily="18" charset="0"/>
              </a:rPr>
              <a:t> miR-142-3p inhibitor or scramble control.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(B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)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ALP staining 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of the colonies of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ESCs (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a-b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). Immunostaining analysis of OCT4 (c-d) and NANOG (e-f). scale bar: a-b =100 </a:t>
            </a:r>
            <a:r>
              <a:rPr lang="en-US" altLang="zh-CN" sz="1200" kern="100" dirty="0" smtClean="0">
                <a:latin typeface="Symbol" panose="05050102010706020507" pitchFamily="18" charset="2"/>
                <a:ea typeface="楷体" panose="02010609060101010101" pitchFamily="49" charset="-122"/>
                <a:cs typeface="Times New Roman" panose="02020603050405020304" pitchFamily="18" charset="0"/>
              </a:rPr>
              <a:t>m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m</a:t>
            </a:r>
            <a:r>
              <a:rPr lang="zh-CN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，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c-f =50</a:t>
            </a:r>
            <a:r>
              <a:rPr lang="en-US" altLang="zh-CN" sz="1200" kern="100" dirty="0" smtClean="0">
                <a:latin typeface="Symbol" panose="05050102010706020507" pitchFamily="18" charset="2"/>
                <a:ea typeface="楷体" panose="02010609060101010101" pitchFamily="49" charset="-122"/>
                <a:cs typeface="Times New Roman" panose="02020603050405020304" pitchFamily="18" charset="0"/>
              </a:rPr>
              <a:t> m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m. (C) </a:t>
            </a:r>
            <a:r>
              <a:rPr lang="en-US" altLang="zh-CN" sz="1200" kern="100" dirty="0" err="1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qRT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-PCR analysis for the expression of the pluripotency marker genes. n=3. (D) Flow cytometry analysis of SSEA1. n=3. 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(E) The percentage of EBs with contracting clusters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during differentiation. n=3.</a:t>
            </a:r>
            <a:endParaRPr lang="en-US" altLang="zh-CN" sz="1200" dirty="0" smtClean="0"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32656" y="344488"/>
            <a:ext cx="612068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dirty="0" smtClean="0" bmk="OLE_LINK27">
                <a:latin typeface="Times New Roman" panose="02020603050405020304" pitchFamily="18" charset="0"/>
                <a:ea typeface="宋体" pitchFamily="2" charset="-122"/>
                <a:cs typeface="Times New Roman" panose="02020603050405020304" pitchFamily="18" charset="0"/>
              </a:rPr>
              <a:t>Figure S2                                                                                  Chen et al. </a:t>
            </a:r>
          </a:p>
        </p:txBody>
      </p:sp>
      <p:pic>
        <p:nvPicPr>
          <p:cNvPr id="1027" name="Picture 3" descr="D:\工作\PUBLICATION\STEM CELLS INTERNATIONAL\figure S2 142 KD on self-renewal and CM differentiation V2 rearranged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1196553"/>
            <a:ext cx="5638800" cy="6708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矩形 7"/>
          <p:cNvSpPr/>
          <p:nvPr/>
        </p:nvSpPr>
        <p:spPr>
          <a:xfrm>
            <a:off x="692696" y="4880992"/>
            <a:ext cx="504056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 smtClean="0" bmk="OLE_LINK27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igure S3. </a:t>
            </a:r>
            <a:r>
              <a:rPr lang="en-US" altLang="zh-CN" sz="1200" kern="100" dirty="0" smtClean="0" bmk="OLE_LINK27">
                <a:latin typeface="Times New Roman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miR-142-3p does not directly target to the 3’UTR of </a:t>
            </a:r>
            <a:r>
              <a:rPr lang="en-US" altLang="zh-CN" sz="1200" i="1" kern="100" dirty="0" smtClean="0" bmk="OLE_LINK27">
                <a:latin typeface="Times New Roman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Mesp1</a:t>
            </a:r>
            <a:r>
              <a:rPr lang="en-US" altLang="zh-CN" sz="1200" kern="100" dirty="0" smtClean="0" bmk="OLE_LINK27">
                <a:latin typeface="Times New Roman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.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(A)</a:t>
            </a:r>
            <a:r>
              <a:rPr lang="en-US" altLang="zh-CN" sz="1200" kern="100" dirty="0" bmk="OLE_LINK27">
                <a:latin typeface="Times New Roman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 err="1" bmk="OLE_LINK27">
                <a:latin typeface="Times New Roman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RNAHybrid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 smtClean="0" bmk="OLE_LINK27">
                <a:latin typeface="Times New Roman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predicts the </a:t>
            </a:r>
            <a:r>
              <a:rPr lang="en-US" altLang="zh-CN" sz="1200" dirty="0" smtClean="0">
                <a:latin typeface="Times New Roman" panose="02020603050405020304" pitchFamily="18" charset="0"/>
                <a:ea typeface="楷体" pitchFamily="49" charset="-122"/>
                <a:cs typeface="Times New Roman" panose="02020603050405020304" pitchFamily="18" charset="0"/>
              </a:rPr>
              <a:t>binding of miR-142-3p to </a:t>
            </a:r>
            <a:r>
              <a:rPr lang="en-US" altLang="zh-CN" sz="1200" kern="100" dirty="0" bmk="OLE_LINK27">
                <a:latin typeface="Times New Roman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the 3’UTR </a:t>
            </a:r>
            <a:r>
              <a:rPr lang="en-US" altLang="zh-CN" sz="1200" kern="100" dirty="0" smtClean="0" bmk="OLE_LINK27">
                <a:latin typeface="Times New Roman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of </a:t>
            </a:r>
            <a:r>
              <a:rPr lang="en-US" altLang="zh-CN" sz="1200" i="1" kern="100" dirty="0" smtClean="0" bmk="OLE_LINK27">
                <a:latin typeface="Times New Roman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Mesp1</a:t>
            </a:r>
            <a:r>
              <a:rPr lang="en-US" altLang="zh-CN" sz="1200" dirty="0" smtClean="0">
                <a:latin typeface="Times New Roman" panose="02020603050405020304" pitchFamily="18" charset="0"/>
                <a:ea typeface="楷体" pitchFamily="49" charset="-122"/>
                <a:cs typeface="Times New Roman" panose="02020603050405020304" pitchFamily="18" charset="0"/>
              </a:rPr>
              <a:t>.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(B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) Luciferase assay determined in HEK293T cells that were transfected with the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3’UTR 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reporter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construct together 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with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miR-142-3p 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mimics or 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scramble.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n=3.</a:t>
            </a:r>
            <a:endParaRPr lang="en-US" altLang="zh-CN" sz="1200" dirty="0" smtClean="0"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32656" y="344488"/>
            <a:ext cx="612068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dirty="0" smtClean="0" bmk="OLE_LINK27">
                <a:latin typeface="Times New Roman" panose="02020603050405020304" pitchFamily="18" charset="0"/>
                <a:ea typeface="宋体" pitchFamily="2" charset="-122"/>
                <a:cs typeface="Times New Roman" panose="02020603050405020304" pitchFamily="18" charset="0"/>
              </a:rPr>
              <a:t>Figure S3                                                                                  Chen et al. </a:t>
            </a:r>
          </a:p>
        </p:txBody>
      </p:sp>
      <p:pic>
        <p:nvPicPr>
          <p:cNvPr id="2051" name="Picture 3" descr="D:\工作\PUBLICATION\STEM CELLS INTERNATIONAL\figure S3 Mesp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1967" y="2288704"/>
            <a:ext cx="3525837" cy="23955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5538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280</TotalTime>
  <Words>494</Words>
  <Application>Microsoft Office PowerPoint</Application>
  <PresentationFormat>A4 纸张(210x297 毫米)</PresentationFormat>
  <Paragraphs>161</Paragraphs>
  <Slides>4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CZY</dc:creator>
  <cp:lastModifiedBy>LMC</cp:lastModifiedBy>
  <cp:revision>1251</cp:revision>
  <cp:lastPrinted>2016-12-23T10:23:56Z</cp:lastPrinted>
  <dcterms:created xsi:type="dcterms:W3CDTF">2016-03-02T08:04:00Z</dcterms:created>
  <dcterms:modified xsi:type="dcterms:W3CDTF">2017-04-05T08:08:21Z</dcterms:modified>
</cp:coreProperties>
</file>